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462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2814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219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265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253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926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690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207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23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889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304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154F07-EC32-4463-AAFB-272E7D33B7B4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5610D5-BD75-4BC9-80AA-7091521E41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463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220BAEB3-CA58-4754-B73A-4DC3A8D00AF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292" t="27065" r="1027" b="4289"/>
          <a:stretch/>
        </p:blipFill>
        <p:spPr>
          <a:xfrm>
            <a:off x="1665327" y="1912690"/>
            <a:ext cx="1519622" cy="4351334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A9E671F-9F38-4804-A918-CAC5179D79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6294280"/>
              </p:ext>
            </p:extLst>
          </p:nvPr>
        </p:nvGraphicFramePr>
        <p:xfrm>
          <a:off x="1080883" y="1912692"/>
          <a:ext cx="564880" cy="4334543"/>
        </p:xfrm>
        <a:graphic>
          <a:graphicData uri="http://schemas.openxmlformats.org/drawingml/2006/table">
            <a:tbl>
              <a:tblPr/>
              <a:tblGrid>
                <a:gridCol w="564880">
                  <a:extLst>
                    <a:ext uri="{9D8B030D-6E8A-4147-A177-3AD203B41FA5}">
                      <a16:colId xmlns:a16="http://schemas.microsoft.com/office/drawing/2014/main" val="3119656243"/>
                    </a:ext>
                  </a:extLst>
                </a:gridCol>
              </a:tblGrid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N2A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771397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t-7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2610022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53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6721736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PR1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6641735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BPB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2167416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7830615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R1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5522620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X2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5520164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L6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8782482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F2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1612344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BB2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3706531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DM1A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4742954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2F3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5269856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RA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9366445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2f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6021275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AP2L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283845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TF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285610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GER2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6811595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XM1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9111131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ND1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1458472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gf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9963158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GF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4125371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R2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4826515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2F1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0734351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L1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9488960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400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4293186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DR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0983882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R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911740"/>
                  </a:ext>
                </a:extLst>
              </a:tr>
              <a:tr h="149467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0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8001699"/>
                  </a:ext>
                </a:extLst>
              </a:tr>
            </a:tbl>
          </a:graphicData>
        </a:graphic>
      </p:graphicFrame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4449AD52-D888-490B-8639-AE2A8EF84F5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27231572"/>
              </p:ext>
            </p:extLst>
          </p:nvPr>
        </p:nvGraphicFramePr>
        <p:xfrm>
          <a:off x="3354942" y="1868659"/>
          <a:ext cx="643296" cy="4464405"/>
        </p:xfrm>
        <a:graphic>
          <a:graphicData uri="http://schemas.openxmlformats.org/drawingml/2006/table">
            <a:tbl>
              <a:tblPr/>
              <a:tblGrid>
                <a:gridCol w="643296">
                  <a:extLst>
                    <a:ext uri="{9D8B030D-6E8A-4147-A177-3AD203B41FA5}">
                      <a16:colId xmlns:a16="http://schemas.microsoft.com/office/drawing/2014/main" val="1685300714"/>
                    </a:ext>
                  </a:extLst>
                </a:gridCol>
              </a:tblGrid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SSF1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909579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M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9796246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KBKB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5801127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3619673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G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6202162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ML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4754930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308123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M2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206150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F1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4388122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1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4127139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B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7884137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KCD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3750296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DF2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8958655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FkB</a:t>
                      </a:r>
                      <a:endParaRPr lang="en-US" sz="9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4746343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FB1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9819148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DM3B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2243751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MARCA4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1296539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FP91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2594127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T5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2655367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K2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8114661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YSF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6193773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mad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3525763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RAD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347444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IF3A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8037127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IG2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2464761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F12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9605808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F2D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9111505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HLHE40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4619121"/>
                  </a:ext>
                </a:extLst>
              </a:tr>
              <a:tr h="153388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6</a:t>
                      </a:r>
                    </a:p>
                  </a:txBody>
                  <a:tcPr marL="7133" marR="7133" marT="71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5587452"/>
                  </a:ext>
                </a:extLst>
              </a:tr>
            </a:tbl>
          </a:graphicData>
        </a:graphic>
      </p:graphicFrame>
      <p:grpSp>
        <p:nvGrpSpPr>
          <p:cNvPr id="14" name="Group 13">
            <a:extLst>
              <a:ext uri="{FF2B5EF4-FFF2-40B4-BE49-F238E27FC236}">
                <a16:creationId xmlns:a16="http://schemas.microsoft.com/office/drawing/2014/main" id="{062608D9-0CBE-40BB-AEFD-CFE555DF83B6}"/>
              </a:ext>
            </a:extLst>
          </p:cNvPr>
          <p:cNvGrpSpPr/>
          <p:nvPr/>
        </p:nvGrpSpPr>
        <p:grpSpPr>
          <a:xfrm>
            <a:off x="1611802" y="1140901"/>
            <a:ext cx="1631216" cy="849164"/>
            <a:chOff x="2840861" y="1006677"/>
            <a:chExt cx="1631216" cy="849164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0646274-6DB2-4A20-AD23-F19BCC983B71}"/>
                </a:ext>
              </a:extLst>
            </p:cNvPr>
            <p:cNvSpPr txBox="1"/>
            <p:nvPr/>
          </p:nvSpPr>
          <p:spPr>
            <a:xfrm rot="16200000">
              <a:off x="3231887" y="615651"/>
              <a:ext cx="849164" cy="1631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1B0FDB7F-AF5C-497B-B051-60496FCA3DA7}"/>
                </a:ext>
              </a:extLst>
            </p:cNvPr>
            <p:cNvCxnSpPr>
              <a:cxnSpLocks/>
            </p:cNvCxnSpPr>
            <p:nvPr/>
          </p:nvCxnSpPr>
          <p:spPr>
            <a:xfrm>
              <a:off x="2883211" y="1431260"/>
              <a:ext cx="74083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CD6C49C5-26F8-4EB3-8AAC-F81A5E35AD46}"/>
                </a:ext>
              </a:extLst>
            </p:cNvPr>
            <p:cNvCxnSpPr>
              <a:cxnSpLocks/>
            </p:cNvCxnSpPr>
            <p:nvPr/>
          </p:nvCxnSpPr>
          <p:spPr>
            <a:xfrm>
              <a:off x="3673175" y="1432658"/>
              <a:ext cx="74083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25D986A-D2CD-49A0-A6D2-2F905F4CE3F9}"/>
                </a:ext>
              </a:extLst>
            </p:cNvPr>
            <p:cNvSpPr txBox="1"/>
            <p:nvPr/>
          </p:nvSpPr>
          <p:spPr>
            <a:xfrm flipH="1">
              <a:off x="3016428" y="1197754"/>
              <a:ext cx="4576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E2E6ECC-6719-4CB9-89C3-13C72DC24913}"/>
                </a:ext>
              </a:extLst>
            </p:cNvPr>
            <p:cNvSpPr txBox="1"/>
            <p:nvPr/>
          </p:nvSpPr>
          <p:spPr>
            <a:xfrm flipH="1">
              <a:off x="3810742" y="1196736"/>
              <a:ext cx="4576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2 h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238719A4-CF6D-4AA6-B684-54C5F1E97873}"/>
              </a:ext>
            </a:extLst>
          </p:cNvPr>
          <p:cNvGrpSpPr/>
          <p:nvPr/>
        </p:nvGrpSpPr>
        <p:grpSpPr>
          <a:xfrm>
            <a:off x="3981460" y="1103382"/>
            <a:ext cx="1631216" cy="849164"/>
            <a:chOff x="2840861" y="1006677"/>
            <a:chExt cx="1631216" cy="849164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799BE8E-40C9-4C51-817D-E8A1CCE6F47B}"/>
                </a:ext>
              </a:extLst>
            </p:cNvPr>
            <p:cNvSpPr txBox="1"/>
            <p:nvPr/>
          </p:nvSpPr>
          <p:spPr>
            <a:xfrm rot="16200000">
              <a:off x="3231887" y="615651"/>
              <a:ext cx="849164" cy="1631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730E3A9A-02AF-40ED-9590-EA4758415C47}"/>
                </a:ext>
              </a:extLst>
            </p:cNvPr>
            <p:cNvCxnSpPr>
              <a:cxnSpLocks/>
            </p:cNvCxnSpPr>
            <p:nvPr/>
          </p:nvCxnSpPr>
          <p:spPr>
            <a:xfrm>
              <a:off x="2883211" y="1431260"/>
              <a:ext cx="74083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0DAD8437-9CA7-45CA-8048-FD92C1E80329}"/>
                </a:ext>
              </a:extLst>
            </p:cNvPr>
            <p:cNvCxnSpPr>
              <a:cxnSpLocks/>
            </p:cNvCxnSpPr>
            <p:nvPr/>
          </p:nvCxnSpPr>
          <p:spPr>
            <a:xfrm>
              <a:off x="3673175" y="1432658"/>
              <a:ext cx="74083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E600802-4A96-42D9-B8D0-C09E97D2F7CD}"/>
                </a:ext>
              </a:extLst>
            </p:cNvPr>
            <p:cNvSpPr txBox="1"/>
            <p:nvPr/>
          </p:nvSpPr>
          <p:spPr>
            <a:xfrm flipH="1">
              <a:off x="3016428" y="1197754"/>
              <a:ext cx="4576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498AA1E-1C44-4B92-B52A-44C41312674C}"/>
                </a:ext>
              </a:extLst>
            </p:cNvPr>
            <p:cNvSpPr txBox="1"/>
            <p:nvPr/>
          </p:nvSpPr>
          <p:spPr>
            <a:xfrm flipH="1">
              <a:off x="3810742" y="1196736"/>
              <a:ext cx="4576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2 h</a:t>
              </a:r>
            </a:p>
          </p:txBody>
        </p:sp>
      </p:grpSp>
      <p:pic>
        <p:nvPicPr>
          <p:cNvPr id="33" name="Picture 32" descr="Diagram&#10;&#10;Description automatically generated">
            <a:extLst>
              <a:ext uri="{FF2B5EF4-FFF2-40B4-BE49-F238E27FC236}">
                <a16:creationId xmlns:a16="http://schemas.microsoft.com/office/drawing/2014/main" id="{519F3571-CCFD-4184-86C2-9AC5294D604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066" t="26902" r="1051" b="4161"/>
          <a:stretch/>
        </p:blipFill>
        <p:spPr>
          <a:xfrm>
            <a:off x="4010197" y="1877046"/>
            <a:ext cx="1535187" cy="44560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Picture 34" descr="Diagram&#10;&#10;Description automatically generated">
            <a:extLst>
              <a:ext uri="{FF2B5EF4-FFF2-40B4-BE49-F238E27FC236}">
                <a16:creationId xmlns:a16="http://schemas.microsoft.com/office/drawing/2014/main" id="{AC9423F0-7126-4D74-94AE-6583BA991DC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550" t="26903" r="879" b="4030"/>
          <a:stretch/>
        </p:blipFill>
        <p:spPr>
          <a:xfrm>
            <a:off x="6416372" y="1815170"/>
            <a:ext cx="1563732" cy="4513501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36" name="Table 35">
            <a:extLst>
              <a:ext uri="{FF2B5EF4-FFF2-40B4-BE49-F238E27FC236}">
                <a16:creationId xmlns:a16="http://schemas.microsoft.com/office/drawing/2014/main" id="{512B62B0-F247-4148-ADC4-E44086023B6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4981932"/>
              </p:ext>
            </p:extLst>
          </p:nvPr>
        </p:nvGraphicFramePr>
        <p:xfrm>
          <a:off x="5462548" y="1818143"/>
          <a:ext cx="941466" cy="4513502"/>
        </p:xfrm>
        <a:graphic>
          <a:graphicData uri="http://schemas.openxmlformats.org/drawingml/2006/table">
            <a:tbl>
              <a:tblPr/>
              <a:tblGrid>
                <a:gridCol w="941466">
                  <a:extLst>
                    <a:ext uri="{9D8B030D-6E8A-4147-A177-3AD203B41FA5}">
                      <a16:colId xmlns:a16="http://schemas.microsoft.com/office/drawing/2014/main" val="588941044"/>
                    </a:ext>
                  </a:extLst>
                </a:gridCol>
              </a:tblGrid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38 MAPK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5102393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RSF1A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8572049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2 (complex)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4640516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DN1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2579155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ITLG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2059032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1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9431303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MGB1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6719608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D88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1870518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0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488436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7809377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 (family)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1106412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SF10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6987092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PK2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1104920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LR4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5980598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21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5495865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9022069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A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5821082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UK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9092166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A2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3953188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KBKG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2818614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F7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5980777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feron alpha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7435989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L1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4193296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O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874737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fat (family)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2580860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F3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3052556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BPD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5751124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H1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2803012"/>
                  </a:ext>
                </a:extLst>
              </a:tr>
              <a:tr h="154950">
                <a:tc>
                  <a:txBody>
                    <a:bodyPr/>
                    <a:lstStyle/>
                    <a:p>
                      <a:pPr algn="r" fontAlgn="b">
                        <a:lnSpc>
                          <a:spcPts val="1400"/>
                        </a:lnSpc>
                      </a:pPr>
                      <a:r>
                        <a:rPr lang="en-US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F</a:t>
                      </a:r>
                    </a:p>
                  </a:txBody>
                  <a:tcPr marL="8826" marR="8826" marT="882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5617539"/>
                  </a:ext>
                </a:extLst>
              </a:tr>
            </a:tbl>
          </a:graphicData>
        </a:graphic>
      </p:graphicFrame>
      <p:grpSp>
        <p:nvGrpSpPr>
          <p:cNvPr id="37" name="Group 36">
            <a:extLst>
              <a:ext uri="{FF2B5EF4-FFF2-40B4-BE49-F238E27FC236}">
                <a16:creationId xmlns:a16="http://schemas.microsoft.com/office/drawing/2014/main" id="{56AF0989-9A1C-4A64-B9BF-1D1DD3E3BFF0}"/>
              </a:ext>
            </a:extLst>
          </p:cNvPr>
          <p:cNvGrpSpPr/>
          <p:nvPr/>
        </p:nvGrpSpPr>
        <p:grpSpPr>
          <a:xfrm>
            <a:off x="6388486" y="1037176"/>
            <a:ext cx="1631216" cy="849164"/>
            <a:chOff x="2840861" y="1006677"/>
            <a:chExt cx="1631216" cy="849164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397CE74-77F6-4AF1-9D01-189BDB45C4AC}"/>
                </a:ext>
              </a:extLst>
            </p:cNvPr>
            <p:cNvSpPr txBox="1"/>
            <p:nvPr/>
          </p:nvSpPr>
          <p:spPr>
            <a:xfrm rot="16200000">
              <a:off x="3231887" y="615651"/>
              <a:ext cx="849164" cy="1631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ts val="1200"/>
                </a:lnSpc>
              </a:pP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716059A2-B2E7-402A-9D1E-3019F21C7FE4}"/>
                </a:ext>
              </a:extLst>
            </p:cNvPr>
            <p:cNvCxnSpPr>
              <a:cxnSpLocks/>
            </p:cNvCxnSpPr>
            <p:nvPr/>
          </p:nvCxnSpPr>
          <p:spPr>
            <a:xfrm>
              <a:off x="2883211" y="1431260"/>
              <a:ext cx="74083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8B914CBD-E0FE-4252-B029-9C9779BEC39D}"/>
                </a:ext>
              </a:extLst>
            </p:cNvPr>
            <p:cNvCxnSpPr>
              <a:cxnSpLocks/>
            </p:cNvCxnSpPr>
            <p:nvPr/>
          </p:nvCxnSpPr>
          <p:spPr>
            <a:xfrm>
              <a:off x="3673175" y="1432658"/>
              <a:ext cx="74083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F08C9DDB-B89B-467E-9FC3-6CE466688841}"/>
                </a:ext>
              </a:extLst>
            </p:cNvPr>
            <p:cNvSpPr txBox="1"/>
            <p:nvPr/>
          </p:nvSpPr>
          <p:spPr>
            <a:xfrm flipH="1">
              <a:off x="3016428" y="1197754"/>
              <a:ext cx="4576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2AFBCCF4-12D2-41FD-84BE-45EA1EF69582}"/>
                </a:ext>
              </a:extLst>
            </p:cNvPr>
            <p:cNvSpPr txBox="1"/>
            <p:nvPr/>
          </p:nvSpPr>
          <p:spPr>
            <a:xfrm flipH="1">
              <a:off x="3810742" y="1196736"/>
              <a:ext cx="4576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2 h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FA89E535-05A4-4A95-9D1C-ABAFBE20FC9C}"/>
              </a:ext>
            </a:extLst>
          </p:cNvPr>
          <p:cNvGrpSpPr/>
          <p:nvPr/>
        </p:nvGrpSpPr>
        <p:grpSpPr>
          <a:xfrm>
            <a:off x="3762717" y="6327765"/>
            <a:ext cx="1915986" cy="560407"/>
            <a:chOff x="3742632" y="6272426"/>
            <a:chExt cx="1915986" cy="560407"/>
          </a:xfrm>
        </p:grpSpPr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B3B09E17-6B51-49D0-8E0C-B3B5C68B41BA}"/>
                </a:ext>
              </a:extLst>
            </p:cNvPr>
            <p:cNvGrpSpPr/>
            <p:nvPr/>
          </p:nvGrpSpPr>
          <p:grpSpPr>
            <a:xfrm>
              <a:off x="3742632" y="6272426"/>
              <a:ext cx="1915986" cy="560407"/>
              <a:chOff x="1787708" y="6278764"/>
              <a:chExt cx="1915986" cy="560407"/>
            </a:xfrm>
          </p:grpSpPr>
          <p:pic>
            <p:nvPicPr>
              <p:cNvPr id="46" name="Picture 45" descr="Diagram&#10;&#10;Description automatically generated">
                <a:extLst>
                  <a:ext uri="{FF2B5EF4-FFF2-40B4-BE49-F238E27FC236}">
                    <a16:creationId xmlns:a16="http://schemas.microsoft.com/office/drawing/2014/main" id="{EED2E4AC-FA17-4AB8-8F8A-509AE26A789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940" t="5078" r="64566" b="92152"/>
              <a:stretch/>
            </p:blipFill>
            <p:spPr>
              <a:xfrm>
                <a:off x="1810121" y="6541931"/>
                <a:ext cx="1847383" cy="136943"/>
              </a:xfrm>
              <a:prstGeom prst="rect">
                <a:avLst/>
              </a:prstGeom>
            </p:spPr>
          </p:pic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60325BC3-DA09-417F-8E4B-23ED5325121B}"/>
                  </a:ext>
                </a:extLst>
              </p:cNvPr>
              <p:cNvSpPr txBox="1"/>
              <p:nvPr/>
            </p:nvSpPr>
            <p:spPr>
              <a:xfrm>
                <a:off x="1787708" y="6577561"/>
                <a:ext cx="191598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.399                              6.091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F277F290-C9BF-4FEA-A75D-9705D5990D3B}"/>
                  </a:ext>
                </a:extLst>
              </p:cNvPr>
              <p:cNvSpPr txBox="1"/>
              <p:nvPr/>
            </p:nvSpPr>
            <p:spPr>
              <a:xfrm>
                <a:off x="2193813" y="6278764"/>
                <a:ext cx="12854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tivation score</a:t>
                </a:r>
              </a:p>
            </p:txBody>
          </p:sp>
        </p:grp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8A80939E-C935-4975-B7B9-BB361ED52B2B}"/>
                </a:ext>
              </a:extLst>
            </p:cNvPr>
            <p:cNvSpPr/>
            <p:nvPr/>
          </p:nvSpPr>
          <p:spPr>
            <a:xfrm>
              <a:off x="3765045" y="6302596"/>
              <a:ext cx="1847383" cy="467320"/>
            </a:xfrm>
            <a:prstGeom prst="rect">
              <a:avLst/>
            </a:prstGeom>
            <a:noFill/>
            <a:ln w="31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noFill/>
              </a:endParaRPr>
            </a:p>
          </p:txBody>
        </p: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B1989DF2-2F2C-4374-AB1D-620710A3A7C8}"/>
              </a:ext>
            </a:extLst>
          </p:cNvPr>
          <p:cNvSpPr txBox="1"/>
          <p:nvPr/>
        </p:nvSpPr>
        <p:spPr>
          <a:xfrm>
            <a:off x="2730561" y="657553"/>
            <a:ext cx="380196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stream regulators- genes and proteins</a:t>
            </a:r>
          </a:p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≤ 0.01; |z| ≥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F36055C-AD4E-46B3-8224-4B19ABD0FD18}"/>
              </a:ext>
            </a:extLst>
          </p:cNvPr>
          <p:cNvSpPr txBox="1"/>
          <p:nvPr/>
        </p:nvSpPr>
        <p:spPr>
          <a:xfrm>
            <a:off x="1211197" y="1203091"/>
            <a:ext cx="323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660CE6C-BAAA-4D9B-BEFC-D8F09B24156C}"/>
              </a:ext>
            </a:extLst>
          </p:cNvPr>
          <p:cNvSpPr txBox="1"/>
          <p:nvPr/>
        </p:nvSpPr>
        <p:spPr>
          <a:xfrm>
            <a:off x="3439654" y="1225416"/>
            <a:ext cx="323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2ACC21F-7C1D-435C-82F7-BB8630525CC7}"/>
              </a:ext>
            </a:extLst>
          </p:cNvPr>
          <p:cNvSpPr txBox="1"/>
          <p:nvPr/>
        </p:nvSpPr>
        <p:spPr>
          <a:xfrm>
            <a:off x="5728731" y="1224447"/>
            <a:ext cx="323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0E7375A-BA7D-4928-A13E-D0D51728F83F}"/>
              </a:ext>
            </a:extLst>
          </p:cNvPr>
          <p:cNvSpPr txBox="1"/>
          <p:nvPr/>
        </p:nvSpPr>
        <p:spPr>
          <a:xfrm>
            <a:off x="-26266" y="-15929"/>
            <a:ext cx="9170265" cy="8649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9: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pstream regulators (genes and proteins) identified in IPA to effect significantly different gene expression profiles across different doses. A), B) and C) represent three different views from the complete list.</a:t>
            </a:r>
          </a:p>
        </p:txBody>
      </p:sp>
    </p:spTree>
    <p:extLst>
      <p:ext uri="{BB962C8B-B14F-4D97-AF65-F5344CB8AC3E}">
        <p14:creationId xmlns:p14="http://schemas.microsoft.com/office/powerpoint/2010/main" val="3475334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233</Words>
  <Application>Microsoft Office PowerPoint</Application>
  <PresentationFormat>On-screen Show (4:3)</PresentationFormat>
  <Paragraphs>1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pra, Sunita (NIH/NCI) [F]</dc:creator>
  <cp:lastModifiedBy>Chopra, Sunita (NIH/NCI) [F]</cp:lastModifiedBy>
  <cp:revision>6</cp:revision>
  <dcterms:created xsi:type="dcterms:W3CDTF">2022-04-27T15:35:27Z</dcterms:created>
  <dcterms:modified xsi:type="dcterms:W3CDTF">2022-08-10T14:37:29Z</dcterms:modified>
</cp:coreProperties>
</file>